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5982CA-5373-421D-B2E6-F385BF97AC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73DB3-2D9F-4DC2-90A9-6743DE4687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12BF6-2209-4105-A891-1DC7649906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ADCEB-92D3-4745-A630-ED0B565482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44AB8-0DBA-4E9A-A836-4AC728471C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68D677-3C19-4F75-93F9-56EFE6102F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2DE4FF-55F4-471E-B070-E6BA8B76CD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56E48-B10F-4824-907B-5CDDAF3DC5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B9756A-A612-4902-8172-0F2290D331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800AD-4AE0-4620-A37F-97FECFFCD5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A22A84-1D5A-445E-90F2-D0CC926D0C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C56FD-8CA1-497E-98A2-C173F8D3AD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98F2E7-B5DC-483E-B772-BD5EF876819A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0"/>
          <p:cNvSpPr/>
          <p:nvPr/>
        </p:nvSpPr>
        <p:spPr>
          <a:xfrm>
            <a:off x="272880" y="210960"/>
            <a:ext cx="132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. Fig. 3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22"/>
          <p:cNvGrpSpPr/>
          <p:nvPr/>
        </p:nvGrpSpPr>
        <p:grpSpPr>
          <a:xfrm>
            <a:off x="277920" y="579600"/>
            <a:ext cx="4365360" cy="1738080"/>
            <a:chOff x="277920" y="579600"/>
            <a:chExt cx="4365360" cy="1738080"/>
          </a:xfrm>
        </p:grpSpPr>
        <p:sp>
          <p:nvSpPr>
            <p:cNvPr id="43" name="TextBox 1"/>
            <p:cNvSpPr/>
            <p:nvPr/>
          </p:nvSpPr>
          <p:spPr>
            <a:xfrm>
              <a:off x="551880" y="579600"/>
              <a:ext cx="1243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Box 15"/>
            <p:cNvSpPr/>
            <p:nvPr/>
          </p:nvSpPr>
          <p:spPr>
            <a:xfrm>
              <a:off x="1940760" y="579600"/>
              <a:ext cx="1243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laceb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16"/>
            <p:cNvSpPr/>
            <p:nvPr/>
          </p:nvSpPr>
          <p:spPr>
            <a:xfrm>
              <a:off x="3193560" y="579600"/>
              <a:ext cx="1243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ritora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2"/>
            <p:cNvSpPr/>
            <p:nvPr/>
          </p:nvSpPr>
          <p:spPr>
            <a:xfrm>
              <a:off x="563400" y="2071440"/>
              <a:ext cx="932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S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18"/>
            <p:cNvSpPr/>
            <p:nvPr/>
          </p:nvSpPr>
          <p:spPr>
            <a:xfrm rot="16200000">
              <a:off x="-65160" y="1467000"/>
              <a:ext cx="933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S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8" name="Straight Arrow Connector 19"/>
            <p:cNvCxnSpPr/>
            <p:nvPr/>
          </p:nvCxnSpPr>
          <p:spPr>
            <a:xfrm>
              <a:off x="569880" y="2091960"/>
              <a:ext cx="112608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49" name="Straight Arrow Connector 20"/>
            <p:cNvCxnSpPr/>
            <p:nvPr/>
          </p:nvCxnSpPr>
          <p:spPr>
            <a:xfrm flipV="1">
              <a:off x="499680" y="1207800"/>
              <a:ext cx="1080" cy="8229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</p:cxnSp>
        <p:grpSp>
          <p:nvGrpSpPr>
            <p:cNvPr id="50" name="Group 13"/>
            <p:cNvGrpSpPr/>
            <p:nvPr/>
          </p:nvGrpSpPr>
          <p:grpSpPr>
            <a:xfrm>
              <a:off x="3144960" y="812880"/>
              <a:ext cx="1498320" cy="1244520"/>
              <a:chOff x="3144960" y="812880"/>
              <a:chExt cx="1498320" cy="1244520"/>
            </a:xfrm>
          </p:grpSpPr>
          <p:pic>
            <p:nvPicPr>
              <p:cNvPr id="51" name="Picture 5" descr=""/>
              <p:cNvPicPr/>
              <p:nvPr/>
            </p:nvPicPr>
            <p:blipFill>
              <a:blip r:embed="rId1"/>
              <a:stretch/>
            </p:blipFill>
            <p:spPr>
              <a:xfrm>
                <a:off x="3193920" y="812880"/>
                <a:ext cx="1271520" cy="1224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TextBox 23"/>
              <p:cNvSpPr/>
              <p:nvPr/>
            </p:nvSpPr>
            <p:spPr>
              <a:xfrm>
                <a:off x="4142880" y="1841760"/>
                <a:ext cx="465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1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Rectangle 38"/>
              <p:cNvSpPr/>
              <p:nvPr/>
            </p:nvSpPr>
            <p:spPr>
              <a:xfrm>
                <a:off x="4125960" y="1201680"/>
                <a:ext cx="233280" cy="147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39"/>
              <p:cNvSpPr/>
              <p:nvPr/>
            </p:nvSpPr>
            <p:spPr>
              <a:xfrm>
                <a:off x="4099320" y="1163160"/>
                <a:ext cx="465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2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Rectangle 43"/>
              <p:cNvSpPr/>
              <p:nvPr/>
            </p:nvSpPr>
            <p:spPr>
              <a:xfrm>
                <a:off x="3387600" y="1746360"/>
                <a:ext cx="195120" cy="77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TextBox 44"/>
              <p:cNvSpPr/>
              <p:nvPr/>
            </p:nvSpPr>
            <p:spPr>
              <a:xfrm>
                <a:off x="3302640" y="1685520"/>
                <a:ext cx="465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3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Rectangle 9"/>
              <p:cNvSpPr/>
              <p:nvPr/>
            </p:nvSpPr>
            <p:spPr>
              <a:xfrm>
                <a:off x="3814920" y="1046160"/>
                <a:ext cx="544320" cy="117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TextBox 10"/>
              <p:cNvSpPr/>
              <p:nvPr/>
            </p:nvSpPr>
            <p:spPr>
              <a:xfrm>
                <a:off x="3696120" y="1022760"/>
                <a:ext cx="868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ranulocyte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Rectangle 51"/>
              <p:cNvSpPr/>
              <p:nvPr/>
            </p:nvSpPr>
            <p:spPr>
              <a:xfrm>
                <a:off x="3205080" y="1590840"/>
                <a:ext cx="330120" cy="110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TextBox 52"/>
              <p:cNvSpPr/>
              <p:nvPr/>
            </p:nvSpPr>
            <p:spPr>
              <a:xfrm>
                <a:off x="3144960" y="1566720"/>
                <a:ext cx="650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Lymph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Rectangle 11"/>
              <p:cNvSpPr/>
              <p:nvPr/>
            </p:nvSpPr>
            <p:spPr>
              <a:xfrm>
                <a:off x="4299120" y="1786320"/>
                <a:ext cx="137880" cy="99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Box 12"/>
              <p:cNvSpPr/>
              <p:nvPr/>
            </p:nvSpPr>
            <p:spPr>
              <a:xfrm>
                <a:off x="4194000" y="1743120"/>
                <a:ext cx="44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O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3" name="Group 14"/>
            <p:cNvGrpSpPr/>
            <p:nvPr/>
          </p:nvGrpSpPr>
          <p:grpSpPr>
            <a:xfrm>
              <a:off x="1835280" y="812880"/>
              <a:ext cx="1511640" cy="1224000"/>
              <a:chOff x="1835280" y="812880"/>
              <a:chExt cx="1511640" cy="1224000"/>
            </a:xfrm>
          </p:grpSpPr>
          <p:pic>
            <p:nvPicPr>
              <p:cNvPr id="64" name="Picture 4" descr=""/>
              <p:cNvPicPr/>
              <p:nvPr/>
            </p:nvPicPr>
            <p:blipFill>
              <a:blip r:embed="rId2"/>
              <a:stretch/>
            </p:blipFill>
            <p:spPr>
              <a:xfrm>
                <a:off x="1896840" y="812880"/>
                <a:ext cx="1270080" cy="1224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5" name="Rectangle 35"/>
              <p:cNvSpPr/>
              <p:nvPr/>
            </p:nvSpPr>
            <p:spPr>
              <a:xfrm>
                <a:off x="2805120" y="1201680"/>
                <a:ext cx="231480" cy="147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TextBox 36"/>
              <p:cNvSpPr/>
              <p:nvPr/>
            </p:nvSpPr>
            <p:spPr>
              <a:xfrm>
                <a:off x="2823480" y="1164240"/>
                <a:ext cx="466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.2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Rectangle 41"/>
              <p:cNvSpPr/>
              <p:nvPr/>
            </p:nvSpPr>
            <p:spPr>
              <a:xfrm>
                <a:off x="2080800" y="1744920"/>
                <a:ext cx="195120" cy="777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TextBox 42"/>
              <p:cNvSpPr/>
              <p:nvPr/>
            </p:nvSpPr>
            <p:spPr>
              <a:xfrm>
                <a:off x="1993320" y="1677600"/>
                <a:ext cx="466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7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Rectangle 47"/>
              <p:cNvSpPr/>
              <p:nvPr/>
            </p:nvSpPr>
            <p:spPr>
              <a:xfrm>
                <a:off x="2547720" y="1046160"/>
                <a:ext cx="541440" cy="117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TextBox 48"/>
              <p:cNvSpPr/>
              <p:nvPr/>
            </p:nvSpPr>
            <p:spPr>
              <a:xfrm>
                <a:off x="2421000" y="1022760"/>
                <a:ext cx="868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ranulocyte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Rectangle 53"/>
              <p:cNvSpPr/>
              <p:nvPr/>
            </p:nvSpPr>
            <p:spPr>
              <a:xfrm>
                <a:off x="1904760" y="1595520"/>
                <a:ext cx="330120" cy="110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TextBox 54"/>
              <p:cNvSpPr/>
              <p:nvPr/>
            </p:nvSpPr>
            <p:spPr>
              <a:xfrm>
                <a:off x="1835280" y="1555560"/>
                <a:ext cx="650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Lymph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Rectangle 59"/>
              <p:cNvSpPr/>
              <p:nvPr/>
            </p:nvSpPr>
            <p:spPr>
              <a:xfrm>
                <a:off x="3003480" y="1794240"/>
                <a:ext cx="136440" cy="99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TextBox 60"/>
              <p:cNvSpPr/>
              <p:nvPr/>
            </p:nvSpPr>
            <p:spPr>
              <a:xfrm>
                <a:off x="2897640" y="1751760"/>
                <a:ext cx="44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O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5" name="Group 21"/>
            <p:cNvGrpSpPr/>
            <p:nvPr/>
          </p:nvGrpSpPr>
          <p:grpSpPr>
            <a:xfrm>
              <a:off x="506160" y="812880"/>
              <a:ext cx="1496520" cy="1242000"/>
              <a:chOff x="506160" y="812880"/>
              <a:chExt cx="1496520" cy="1242000"/>
            </a:xfrm>
          </p:grpSpPr>
          <p:pic>
            <p:nvPicPr>
              <p:cNvPr id="76" name="Picture 3" descr=""/>
              <p:cNvPicPr/>
              <p:nvPr/>
            </p:nvPicPr>
            <p:blipFill>
              <a:blip r:embed="rId3"/>
              <a:stretch/>
            </p:blipFill>
            <p:spPr>
              <a:xfrm>
                <a:off x="560160" y="812880"/>
                <a:ext cx="1271520" cy="12254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77" name="Group 17"/>
              <p:cNvGrpSpPr/>
              <p:nvPr/>
            </p:nvGrpSpPr>
            <p:grpSpPr>
              <a:xfrm>
                <a:off x="506160" y="1022400"/>
                <a:ext cx="1496520" cy="1032480"/>
                <a:chOff x="506160" y="1022400"/>
                <a:chExt cx="1496520" cy="1032480"/>
              </a:xfrm>
            </p:grpSpPr>
            <p:sp>
              <p:nvSpPr>
                <p:cNvPr id="78" name="TextBox 29"/>
                <p:cNvSpPr/>
                <p:nvPr/>
              </p:nvSpPr>
              <p:spPr>
                <a:xfrm>
                  <a:off x="1513080" y="1839240"/>
                  <a:ext cx="466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.74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" name="Rectangle 5"/>
                <p:cNvSpPr/>
                <p:nvPr/>
              </p:nvSpPr>
              <p:spPr>
                <a:xfrm>
                  <a:off x="712440" y="1744560"/>
                  <a:ext cx="193680" cy="777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960" bIns="3096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" name="TextBox 32"/>
                <p:cNvSpPr/>
                <p:nvPr/>
              </p:nvSpPr>
              <p:spPr>
                <a:xfrm>
                  <a:off x="627840" y="1667880"/>
                  <a:ext cx="466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6.04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" name="Rectangle 6"/>
                <p:cNvSpPr/>
                <p:nvPr/>
              </p:nvSpPr>
              <p:spPr>
                <a:xfrm>
                  <a:off x="1490760" y="1209240"/>
                  <a:ext cx="231480" cy="1476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" name="TextBox 34"/>
                <p:cNvSpPr/>
                <p:nvPr/>
              </p:nvSpPr>
              <p:spPr>
                <a:xfrm>
                  <a:off x="1509480" y="1164240"/>
                  <a:ext cx="466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.43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" name="Rectangle 49"/>
                <p:cNvSpPr/>
                <p:nvPr/>
              </p:nvSpPr>
              <p:spPr>
                <a:xfrm>
                  <a:off x="1147680" y="1045800"/>
                  <a:ext cx="544320" cy="1173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" name="TextBox 50"/>
                <p:cNvSpPr/>
                <p:nvPr/>
              </p:nvSpPr>
              <p:spPr>
                <a:xfrm>
                  <a:off x="1094040" y="1022400"/>
                  <a:ext cx="868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Granulocyte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" name="Rectangle 55"/>
                <p:cNvSpPr/>
                <p:nvPr/>
              </p:nvSpPr>
              <p:spPr>
                <a:xfrm>
                  <a:off x="582480" y="1600200"/>
                  <a:ext cx="330120" cy="1108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" name="TextBox 56"/>
                <p:cNvSpPr/>
                <p:nvPr/>
              </p:nvSpPr>
              <p:spPr>
                <a:xfrm>
                  <a:off x="506160" y="1530000"/>
                  <a:ext cx="6501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ymphs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" name="Rectangle 61"/>
                <p:cNvSpPr/>
                <p:nvPr/>
              </p:nvSpPr>
              <p:spPr>
                <a:xfrm>
                  <a:off x="1668600" y="1789200"/>
                  <a:ext cx="137880" cy="997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" name="TextBox 62"/>
                <p:cNvSpPr/>
                <p:nvPr/>
              </p:nvSpPr>
              <p:spPr>
                <a:xfrm>
                  <a:off x="1553400" y="1751400"/>
                  <a:ext cx="449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MO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89" name="TextBox 67"/>
            <p:cNvSpPr/>
            <p:nvPr/>
          </p:nvSpPr>
          <p:spPr>
            <a:xfrm>
              <a:off x="2842560" y="1839240"/>
              <a:ext cx="46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6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12T19:04:43Z</dcterms:created>
  <dc:creator>Windows User</dc:creator>
  <dc:description/>
  <dc:language>en-US</dc:language>
  <cp:lastModifiedBy>Alex Bukreyev</cp:lastModifiedBy>
  <dcterms:modified xsi:type="dcterms:W3CDTF">2017-04-03T17:44:23Z</dcterms:modified>
  <cp:revision>82</cp:revision>
  <dc:subject/>
  <dc:title>Supplementary Figures</dc:title>
</cp:coreProperties>
</file>